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68" r:id="rId2"/>
  </p:sldIdLst>
  <p:sldSz cx="6858000" cy="9144000" type="letter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3CDEF"/>
    <a:srgbClr val="FFCCCC"/>
    <a:srgbClr val="2C11F7"/>
    <a:srgbClr val="CCFFCC"/>
    <a:srgbClr val="CCCCFF"/>
    <a:srgbClr val="00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4" autoAdjust="0"/>
    <p:restoredTop sz="94660"/>
  </p:normalViewPr>
  <p:slideViewPr>
    <p:cSldViewPr snapToGrid="0">
      <p:cViewPr varScale="1">
        <p:scale>
          <a:sx n="77" d="100"/>
          <a:sy n="77" d="100"/>
        </p:scale>
        <p:origin x="24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94" d="100"/>
          <a:sy n="94" d="100"/>
        </p:scale>
        <p:origin x="2862" y="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75F1C848-E130-413A-A8DA-8172A53B0D88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4C6F3B48-2B3A-4C55-BDFB-E1E416627B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933520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DCB9EB20-C2EB-4A46-8805-2479D3AB5F2C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43163" y="1200150"/>
            <a:ext cx="242887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F07D6EC-DFDD-4EE7-ACA8-6578442E63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5759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07D6EC-DFDD-4EE7-ACA8-6578442E636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07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2505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3039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212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359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9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7647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4123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063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009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1145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0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FA121-334F-4260-895F-9089C15D1BA6}" type="datetimeFigureOut">
              <a:rPr lang="en-US" smtClean="0"/>
              <a:t>3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95D219-400D-48BB-8402-3404BDD7B5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581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07535" y="740284"/>
            <a:ext cx="4573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S6. Primer List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9636318"/>
              </p:ext>
            </p:extLst>
          </p:nvPr>
        </p:nvGraphicFramePr>
        <p:xfrm>
          <a:off x="397613" y="1260550"/>
          <a:ext cx="6242106" cy="5546100"/>
        </p:xfrm>
        <a:graphic>
          <a:graphicData uri="http://schemas.openxmlformats.org/drawingml/2006/table">
            <a:tbl>
              <a:tblPr/>
              <a:tblGrid>
                <a:gridCol w="132264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2632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9313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894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me </a:t>
                      </a:r>
                    </a:p>
                  </a:txBody>
                  <a:tcPr marR="6111" marT="6111" marB="0" anchor="ctr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quence (5' to 3')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ote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9427">
                <a:tc gridSpan="3"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en-US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Primers used in CRISP/Cas9</a:t>
                      </a:r>
                    </a:p>
                  </a:txBody>
                  <a:tcPr marR="6111" marT="611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27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2_PDC1_gDNA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TACTAGCTGTCCTCGTTGAACATGTTTTAGAGCTA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DC1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DNA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20mer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27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2_PDC1_gDNA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AGCTCTAAAACATGTTCAACGAGGACAGCTA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768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CIS3_gDNA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TCTCCGCAGTGAAAGATAAAtgatcagtgggtgaaaaattctcgaGTTTTAGAGCT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IS3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DNA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20mer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27688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en-US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PR1_CIS3_gDNA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en-US" sz="1000" b="0" i="0" u="none" strike="noStrike" kern="120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GTTGATAACGGACTAGCCTTATTTTAACTTGCTATTTCTAGCTCTAAAACtcgagaat</a:t>
                      </a:r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9427">
                <a:tc gridSpan="3"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en-US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Primers used in CHIP</a:t>
                      </a:r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R="6111" marT="6111" marB="0" anchor="ctr">
                    <a:lnL>
                      <a:noFill/>
                    </a:lnL>
                    <a:lnR w="6350" cap="flat" cmpd="sng" algn="ctr">
                      <a:noFill/>
                      <a:prstDash val="sysDot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 marR="6111" marT="6111" marB="0" anchor="ctr">
                    <a:lnL w="63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952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2_Venus_TC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TGGTGATGGTCCAGTCTT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FP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sORF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(CHIP)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2_Venus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TCTTTTCGTTTGGATCTTTG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3_mCherry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TAAGAAACCGGTACAATTAC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Cherry dsORF (CHIP)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3_mCherry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TCTACAATCGTATAGTCTT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MY-F1-ACT1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TAACGAAAGATTCAGAGCCC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T1</a:t>
                      </a:r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dsORF (CHIP)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MY-R1-ACT1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GACATCACACTTCATGATGGA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KanMXp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TTACGGCTCCTCGCTGCAGA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anMXpr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CHIP)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1_KanMXpr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AAGAACCTCAGTGGCAAATC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IP_Met3_F1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GAAGCGCCCTTTGCGGTA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3pr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CHIP)</a:t>
                      </a:r>
                      <a:endParaRPr lang="en-US" sz="10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IP_Met3_R1      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CTTATAGGCTGATTCCTTT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91484">
                <a:tc gridSpan="3">
                  <a:txBody>
                    <a:bodyPr/>
                    <a:lstStyle/>
                    <a:p>
                      <a:pPr marL="0" lvl="0" algn="l" defTabSz="685800" rtl="0" eaLnBrk="1" fontAlgn="b" latinLnBrk="0" hangingPunct="1">
                        <a:lnSpc>
                          <a:spcPct val="150000"/>
                        </a:lnSpc>
                      </a:pPr>
                      <a:r>
                        <a:rPr lang="en-US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Primers used in 3C and quantitative PCR</a:t>
                      </a:r>
                      <a:endParaRPr lang="en-US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+mn-cs"/>
                      </a:endParaRPr>
                    </a:p>
                  </a:txBody>
                  <a:tcPr marR="6111" marT="611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1_Skud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TTGAATGTGCACGCTTTG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. </a:t>
                      </a:r>
                      <a:r>
                        <a:rPr lang="en-US" sz="10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Kud</a:t>
                      </a:r>
                      <a:r>
                        <a:rPr lang="en-US" sz="10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MET3pr-GFP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PCL10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TACGGATGTGGAGGAGCAA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r7 positive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ADK1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GCGTAGTTACCTCTTCTTAG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5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file 4 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ite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GTO1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CACGTGATAGTAGTGGCTCA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XKS1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ACAAGATGGCCCACTAAGATA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SER33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AAGAGATAGCATGTTTGGTGA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PDR12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GGTTAAGGGTGATTCAACGTATA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MET13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CATCTGTCCACGGACTTGGTT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ET13</a:t>
                      </a: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RF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AIM39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CATTGTTTCCATCATCCAAGATA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r15 positive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ntrol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RPL1A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TTCATGTCTCTATAAAAAGA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ative control 1 (N1)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MET28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TTTCCTCTTCTGAGTTGAA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egative control 2 (N2)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MET1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TGTTACCCGGTTTGGCCAACATT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3"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rofile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 Met4 targeted genes</a:t>
                      </a:r>
                    </a:p>
                  </a:txBody>
                  <a:tcPr marR="6111" marT="6111" marB="0" anchor="ctr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MET6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CTGCCGGTATCAAGGTTATCCAAG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2221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F1_MET8</a:t>
                      </a:r>
                    </a:p>
                  </a:txBody>
                  <a:tcPr marR="6111" marT="6111" marB="0" anchor="b">
                    <a:lnL>
                      <a:noFill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GCTGTTCCTATGACCCAGACGCC</a:t>
                      </a:r>
                    </a:p>
                  </a:txBody>
                  <a:tcPr marR="6111" marT="6111" marB="0" anchor="b">
                    <a:lnL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270312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43</TotalTime>
  <Words>147</Words>
  <Application>Microsoft Office PowerPoint</Application>
  <PresentationFormat>Letter Paper (8.5x11 in)</PresentationFormat>
  <Paragraphs>7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yu Du</dc:creator>
  <cp:lastModifiedBy>lucybai</cp:lastModifiedBy>
  <cp:revision>282</cp:revision>
  <cp:lastPrinted>2016-12-22T22:05:19Z</cp:lastPrinted>
  <dcterms:created xsi:type="dcterms:W3CDTF">2016-06-14T18:48:14Z</dcterms:created>
  <dcterms:modified xsi:type="dcterms:W3CDTF">2017-03-30T15:30:47Z</dcterms:modified>
</cp:coreProperties>
</file>